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12" d="100"/>
          <a:sy n="112" d="100"/>
        </p:scale>
        <p:origin x="96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Borowicz, Cassie J" userId="3197107a-b8ad-4a73-a824-9c12b8a4ee55" providerId="ADAL" clId="{212BC637-B372-46E2-9CC8-68DFF1E14223}"/>
    <pc:docChg chg="undo custSel modSld">
      <pc:chgData name="Borowicz, Cassie J" userId="3197107a-b8ad-4a73-a824-9c12b8a4ee55" providerId="ADAL" clId="{212BC637-B372-46E2-9CC8-68DFF1E14223}" dt="2023-09-11T15:10:01.535" v="10" actId="1076"/>
      <pc:docMkLst>
        <pc:docMk/>
      </pc:docMkLst>
      <pc:sldChg chg="modSp mod">
        <pc:chgData name="Borowicz, Cassie J" userId="3197107a-b8ad-4a73-a824-9c12b8a4ee55" providerId="ADAL" clId="{212BC637-B372-46E2-9CC8-68DFF1E14223}" dt="2023-09-11T15:10:01.535" v="10" actId="1076"/>
        <pc:sldMkLst>
          <pc:docMk/>
          <pc:sldMk cId="2801619402" sldId="256"/>
        </pc:sldMkLst>
        <pc:spChg chg="mod">
          <ac:chgData name="Borowicz, Cassie J" userId="3197107a-b8ad-4a73-a824-9c12b8a4ee55" providerId="ADAL" clId="{212BC637-B372-46E2-9CC8-68DFF1E14223}" dt="2023-09-11T15:10:01.535" v="10" actId="1076"/>
          <ac:spMkLst>
            <pc:docMk/>
            <pc:sldMk cId="2801619402" sldId="256"/>
            <ac:spMk id="4" creationId="{1BAF2DD7-A011-58DC-0F98-1B9C0C50D975}"/>
          </ac:spMkLst>
        </pc:spChg>
      </pc:sldChg>
      <pc:sldChg chg="modSp mod">
        <pc:chgData name="Borowicz, Cassie J" userId="3197107a-b8ad-4a73-a824-9c12b8a4ee55" providerId="ADAL" clId="{212BC637-B372-46E2-9CC8-68DFF1E14223}" dt="2023-09-11T15:09:42.654" v="5" actId="1076"/>
        <pc:sldMkLst>
          <pc:docMk/>
          <pc:sldMk cId="2036770371" sldId="257"/>
        </pc:sldMkLst>
        <pc:spChg chg="mod">
          <ac:chgData name="Borowicz, Cassie J" userId="3197107a-b8ad-4a73-a824-9c12b8a4ee55" providerId="ADAL" clId="{212BC637-B372-46E2-9CC8-68DFF1E14223}" dt="2023-09-11T15:09:42.654" v="5" actId="1076"/>
          <ac:spMkLst>
            <pc:docMk/>
            <pc:sldMk cId="2036770371" sldId="257"/>
            <ac:spMk id="5" creationId="{069B0494-FECF-2FC5-2959-6DA6D4492515}"/>
          </ac:spMkLst>
        </pc:spChg>
      </pc:sldChg>
      <pc:sldChg chg="modSp mod">
        <pc:chgData name="Borowicz, Cassie J" userId="3197107a-b8ad-4a73-a824-9c12b8a4ee55" providerId="ADAL" clId="{212BC637-B372-46E2-9CC8-68DFF1E14223}" dt="2023-09-11T15:09:36.229" v="4" actId="1076"/>
        <pc:sldMkLst>
          <pc:docMk/>
          <pc:sldMk cId="949140364" sldId="258"/>
        </pc:sldMkLst>
        <pc:spChg chg="mod">
          <ac:chgData name="Borowicz, Cassie J" userId="3197107a-b8ad-4a73-a824-9c12b8a4ee55" providerId="ADAL" clId="{212BC637-B372-46E2-9CC8-68DFF1E14223}" dt="2023-09-11T15:09:36.229" v="4" actId="1076"/>
          <ac:spMkLst>
            <pc:docMk/>
            <pc:sldMk cId="949140364" sldId="258"/>
            <ac:spMk id="3" creationId="{90CA47BA-C0C1-3280-74E5-A12B5C29F7E7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312B3D-C22D-0247-DDEA-C3E0616A05F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AA4B01E-40FF-3B24-8C89-4795FDCD202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CE9DC7D-60FE-5208-E52B-118B39B968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ACE7E8-ABE9-48D8-B513-382F5038FFCE}" type="datetimeFigureOut">
              <a:rPr lang="en-US" smtClean="0"/>
              <a:t>9/1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AA08C94-2E3C-3FE0-1B56-DF9A9F40E5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E4DDAEC-D29B-B913-0339-0296A8B868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DA5657-C707-414C-98B3-1AD1EFC057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15013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CAB8124-E0F1-E037-5182-B9966045D1F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3D77390-6D87-22DC-2EBB-5DBBC8298EC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734EBBC-E22E-1D0D-2A36-D7FE392154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ACE7E8-ABE9-48D8-B513-382F5038FFCE}" type="datetimeFigureOut">
              <a:rPr lang="en-US" smtClean="0"/>
              <a:t>9/1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5C248DE-A18A-49A8-E2BE-539B14836F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8607E69-092F-ECA2-5125-33AAA586E0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DA5657-C707-414C-98B3-1AD1EFC057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69979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69FA298-9597-2698-FB78-5A2317BAF4F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CAFDABF-CFD6-57AC-BAA3-7DA608D6F90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91BA480-45BC-6CA4-08EF-94D8FAC1FF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ACE7E8-ABE9-48D8-B513-382F5038FFCE}" type="datetimeFigureOut">
              <a:rPr lang="en-US" smtClean="0"/>
              <a:t>9/1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B1368DC-832C-64EB-A395-9D75697860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A0D20B6-8D2D-C11F-AAF8-682C2ED07E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DA5657-C707-414C-98B3-1AD1EFC057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02407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E80357-0C0F-0A8B-B51D-CC1F1A0740A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9F573C8-05EC-319E-11E5-F34C7FB0538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D6F0CFE-1B59-A0E5-F683-3349B67B5B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ACE7E8-ABE9-48D8-B513-382F5038FFCE}" type="datetimeFigureOut">
              <a:rPr lang="en-US" smtClean="0"/>
              <a:t>9/1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29D8F83-35AC-71D8-6C3B-D2066343E1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937BA8F-3811-8B73-8732-008FC031D8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DA5657-C707-414C-98B3-1AD1EFC057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21058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13E73C-47F5-21F0-0A03-587A7D6D00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30FDBE9-5A7A-17FD-98A4-34C8D1DF062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C6A9EA8-B212-07B3-1377-A4348EFEF8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ACE7E8-ABE9-48D8-B513-382F5038FFCE}" type="datetimeFigureOut">
              <a:rPr lang="en-US" smtClean="0"/>
              <a:t>9/1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DFFD30C-5286-1CA4-693C-DBFF8651B1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E6DC09F-F87B-E227-9D5A-4A701D16B2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DA5657-C707-414C-98B3-1AD1EFC057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13733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5B7D8B-3C0A-66E1-6F20-4D4551D0C1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DE5351F-39A8-DAB7-2BF0-3F78253AB7E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7E0322E-74CC-CCF7-5367-71BE9073EE3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B248DCD-D2EA-8A58-233D-B8EFE98445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ACE7E8-ABE9-48D8-B513-382F5038FFCE}" type="datetimeFigureOut">
              <a:rPr lang="en-US" smtClean="0"/>
              <a:t>9/11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E1FA4FD-9A29-3167-9E41-F7CD5B7CD7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3B8F709-809F-D44B-F698-07D4E9ECCA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DA5657-C707-414C-98B3-1AD1EFC057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29762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A54722-AF1D-8E70-5C5B-971AB55E9B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AFABE02-637F-8E87-828F-2FE57CD2C62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034A688-5466-0839-230B-71DAE70FE7C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D476FA7-38B6-0DE5-D112-DE0F1EC10CA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1DB1A23-D73C-4F17-34CC-15E2272EC67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073334A-B98C-38EB-29A3-C97350BCF8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ACE7E8-ABE9-48D8-B513-382F5038FFCE}" type="datetimeFigureOut">
              <a:rPr lang="en-US" smtClean="0"/>
              <a:t>9/11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70A71B9-B7AE-5B6B-5F1F-876CE078AC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F7DAA81-5345-B12B-7E51-02D0B8F315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DA5657-C707-414C-98B3-1AD1EFC057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03855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C1424F-AD34-7A89-096A-9A854273652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75A6DB1-A7D0-F79C-D66F-DC007C1B4D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ACE7E8-ABE9-48D8-B513-382F5038FFCE}" type="datetimeFigureOut">
              <a:rPr lang="en-US" smtClean="0"/>
              <a:t>9/11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C6C5608-A63C-F57F-8868-B907A1F90B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7FB5A32-48B2-DD79-2D39-BCDC2A55AB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DA5657-C707-414C-98B3-1AD1EFC057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98834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CEB0C5B-D8A1-E14D-F3AB-6C5DD7A02D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ACE7E8-ABE9-48D8-B513-382F5038FFCE}" type="datetimeFigureOut">
              <a:rPr lang="en-US" smtClean="0"/>
              <a:t>9/11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C76FB58-AE08-1F27-72B3-9499F01B3C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9347122-158A-2DC3-47EC-748126BD05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DA5657-C707-414C-98B3-1AD1EFC057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16928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4C8F09-5B4E-5907-5888-FE3158E77F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82DFEA6-A3CD-53A5-019A-CA0D88766D0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0754C4A-CABC-4FA5-3B02-3F4CBFCAE62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DBFF1ED-D527-F721-7BDD-52AC607987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ACE7E8-ABE9-48D8-B513-382F5038FFCE}" type="datetimeFigureOut">
              <a:rPr lang="en-US" smtClean="0"/>
              <a:t>9/11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3B3D406-F0AD-D5F5-BF89-F05D4A435F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04BD675-F7BD-7C78-5E80-8B0525A3AF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DA5657-C707-414C-98B3-1AD1EFC057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94361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94B221-4D43-0A6D-6793-C17211D94B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713CE00-8F05-FEA3-3654-2EBBEA1C5E7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FCD4C7F-BCA0-4D4C-3DBA-C45AA1290E5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9484E66-E995-045F-D97C-41B6063086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ACE7E8-ABE9-48D8-B513-382F5038FFCE}" type="datetimeFigureOut">
              <a:rPr lang="en-US" smtClean="0"/>
              <a:t>9/11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5C1EE29-DBF5-38B9-24A1-1BC5B7DE63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BCD4C96-89F0-B2A7-047F-22642A72A4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DA5657-C707-414C-98B3-1AD1EFC057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88232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6582BB3-4064-EEB7-D55D-C61D6EB17C9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EF841BA-9203-D348-D505-8A37F1C27CE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34CCE5D-B34E-551E-DEA9-04A352C4821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ACE7E8-ABE9-48D8-B513-382F5038FFCE}" type="datetimeFigureOut">
              <a:rPr lang="en-US" smtClean="0"/>
              <a:t>9/1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C173869-1455-EF98-F62A-3B62EE83C5A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F692684-10AB-9613-FF24-6750A5D7F97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DA5657-C707-414C-98B3-1AD1EFC057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52517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10" name="Rectangle 9">
            <a:extLst>
              <a:ext uri="{FF2B5EF4-FFF2-40B4-BE49-F238E27FC236}">
                <a16:creationId xmlns:a16="http://schemas.microsoft.com/office/drawing/2014/main" id="{C27D7A02-907B-496F-BA7E-AA3780733CA7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92000" cy="6858000"/>
          </a:xfrm>
          <a:prstGeom prst="rect">
            <a:avLst/>
          </a:prstGeom>
          <a:ln w="12700" cap="flat" cmpd="sng" algn="ctr">
            <a:noFill/>
            <a:prstDash val="solid"/>
            <a:miter lim="800000"/>
          </a:ln>
          <a:effectLst/>
          <a:extLst>
            <a:ext uri="{91240B29-F687-4F45-9708-019B960494DF}">
              <a14:hiddenLine xmlns:a14="http://schemas.microsoft.com/office/drawing/2010/main" w="12700" cap="flat" cmpd="sng" algn="ctr">
                <a:solidFill>
                  <a:schemeClr val="accent1">
                    <a:shade val="50000"/>
                  </a:schemeClr>
                </a:solidFill>
                <a:prstDash val="solid"/>
                <a:miter lim="800000"/>
              </a14:hiddenLine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0FBA5268-0AE7-4CAD-9537-D0EB09E76406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92000" cy="6858000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088D065B-39DA-4077-B9CF-E489CE4C016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685800" y="685800"/>
            <a:ext cx="10820400" cy="54864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Title 3">
            <a:extLst>
              <a:ext uri="{FF2B5EF4-FFF2-40B4-BE49-F238E27FC236}">
                <a16:creationId xmlns:a16="http://schemas.microsoft.com/office/drawing/2014/main" id="{1BAF2DD7-A011-58DC-0F98-1B9C0C50D97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653552" y="3064928"/>
            <a:ext cx="6884895" cy="728143"/>
          </a:xfrm>
        </p:spPr>
        <p:txBody>
          <a:bodyPr vert="horz" lIns="91440" tIns="45720" rIns="91440" bIns="45720" rtlCol="0" anchor="b">
            <a:normAutofit/>
          </a:bodyPr>
          <a:lstStyle/>
          <a:p>
            <a:pPr algn="ctr"/>
            <a:r>
              <a:rPr lang="en-US" sz="4400" b="1" kern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ject Overview</a:t>
            </a:r>
          </a:p>
        </p:txBody>
      </p:sp>
    </p:spTree>
    <p:extLst>
      <p:ext uri="{BB962C8B-B14F-4D97-AF65-F5344CB8AC3E}">
        <p14:creationId xmlns:p14="http://schemas.microsoft.com/office/powerpoint/2010/main" val="280161940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069B0494-FECF-2FC5-2959-6DA6D4492515}"/>
              </a:ext>
            </a:extLst>
          </p:cNvPr>
          <p:cNvSpPr txBox="1"/>
          <p:nvPr/>
        </p:nvSpPr>
        <p:spPr>
          <a:xfrm>
            <a:off x="1328057" y="982176"/>
            <a:ext cx="9535886" cy="489364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sz="2400" kern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 team of software engineers at HealthPartners Institute developed an EHR-integrated, provider facing CDS to deliver personalized pain management options for patients after a dental extraction. 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sz="2400" kern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is CDS was deployed as part of a randomized clinical trial conducted in a large dental group practice within the HealthPartners, a large health care system. 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sz="2400" kern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is SMART on FHIR application serves as the infrastructure for the CDS intervention. 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sz="2400" kern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entists were randomly assigned to 1 of 3 arms: Standard Practice, CDS, and CDS enhanced with patient education materials (CDS-E).[14] 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sz="2400" kern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 CDS integrated the relevant prescribing information into one interface to guide the dentist in the delivery of personalized and safe analgesic prescribing. </a:t>
            </a:r>
            <a:endParaRPr 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3677037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90CA47BA-C0C1-3280-74E5-A12B5C29F7E7}"/>
              </a:ext>
            </a:extLst>
          </p:cNvPr>
          <p:cNvSpPr txBox="1"/>
          <p:nvPr/>
        </p:nvSpPr>
        <p:spPr>
          <a:xfrm>
            <a:off x="1191986" y="1905506"/>
            <a:ext cx="9808028" cy="304698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2400" kern="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The CDS was developed as a provider-facing point-of-care tool that: </a:t>
            </a:r>
          </a:p>
          <a:p>
            <a:pPr marL="1028700" lvl="1" indent="-571500">
              <a:buAutoNum type="romanLcParenBoth"/>
            </a:pPr>
            <a:r>
              <a:rPr lang="en-US" sz="2400" kern="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pulls into the CDS screen all medical information relevant to analgesic prescribing, </a:t>
            </a:r>
          </a:p>
          <a:p>
            <a:pPr marL="1028700" lvl="1" indent="-571500">
              <a:buAutoNum type="romanLcParenBoth"/>
            </a:pPr>
            <a:r>
              <a:rPr lang="en-US" sz="2400" kern="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utilizes EHR notification features to alert the providers when an extraction is planned, and </a:t>
            </a:r>
          </a:p>
          <a:p>
            <a:pPr marL="1028700" lvl="1" indent="-571500">
              <a:buAutoNum type="romanLcParenBoth"/>
            </a:pPr>
            <a:r>
              <a:rPr lang="en-US" sz="2400" kern="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provides personalized clinical recommendations for safer pain medications based on the patients’ relevant medical history and current medications.</a:t>
            </a:r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9491403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</TotalTime>
  <Words>184</Words>
  <Application>Microsoft Office PowerPoint</Application>
  <PresentationFormat>Widescreen</PresentationFormat>
  <Paragraphs>10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Theme</vt:lpstr>
      <vt:lpstr>Project Overview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DS Development Overview</dc:title>
  <dc:creator>Rindal, D Brad</dc:creator>
  <cp:lastModifiedBy>Borowicz, Cassie J</cp:lastModifiedBy>
  <cp:revision>3</cp:revision>
  <dcterms:created xsi:type="dcterms:W3CDTF">2023-09-08T16:48:34Z</dcterms:created>
  <dcterms:modified xsi:type="dcterms:W3CDTF">2023-09-11T15:10:02Z</dcterms:modified>
</cp:coreProperties>
</file>